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63" r:id="rId2"/>
    <p:sldId id="267" r:id="rId3"/>
    <p:sldId id="265" r:id="rId4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ta" initials="m" lastIdx="2" clrIdx="0">
    <p:extLst>
      <p:ext uri="{19B8F6BF-5375-455C-9EA6-DF929625EA0E}">
        <p15:presenceInfo xmlns:p15="http://schemas.microsoft.com/office/powerpoint/2012/main" userId="mart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63"/>
  </p:normalViewPr>
  <p:slideViewPr>
    <p:cSldViewPr>
      <p:cViewPr varScale="1">
        <p:scale>
          <a:sx n="120" d="100"/>
          <a:sy n="120" d="100"/>
        </p:scale>
        <p:origin x="1110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P</a:t>
            </a:r>
            <a:r>
              <a:rPr lang="it-IT" sz="1200" b="1" baseline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U/I)</a:t>
            </a:r>
            <a:endParaRPr lang="it-IT" sz="12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9974300087489065"/>
          <c:y val="0.101851851851851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75-49F5-8459-D5A0E4649F3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5075-49F5-8459-D5A0E4649F3C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075-49F5-8459-D5A0E4649F3C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5075-49F5-8459-D5A0E4649F3C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075-49F5-8459-D5A0E4649F3C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5075-49F5-8459-D5A0E4649F3C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075-49F5-8459-D5A0E4649F3C}"/>
              </c:ext>
            </c:extLst>
          </c:dPt>
          <c:errBars>
            <c:errBarType val="both"/>
            <c:errValType val="cust"/>
            <c:noEndCap val="0"/>
            <c:plus>
              <c:numRef>
                <c:f>Foglio2!$R$131:$R$138</c:f>
                <c:numCache>
                  <c:formatCode>General</c:formatCode>
                  <c:ptCount val="8"/>
                  <c:pt idx="0">
                    <c:v>20.7</c:v>
                  </c:pt>
                  <c:pt idx="1">
                    <c:v>203.2</c:v>
                  </c:pt>
                  <c:pt idx="2">
                    <c:v>57.7</c:v>
                  </c:pt>
                  <c:pt idx="3">
                    <c:v>83.28</c:v>
                  </c:pt>
                  <c:pt idx="4">
                    <c:v>86.06</c:v>
                  </c:pt>
                  <c:pt idx="5">
                    <c:v>48.33</c:v>
                  </c:pt>
                  <c:pt idx="6">
                    <c:v>92.8</c:v>
                  </c:pt>
                  <c:pt idx="7">
                    <c:v>89.3</c:v>
                  </c:pt>
                </c:numCache>
              </c:numRef>
            </c:plus>
            <c:minus>
              <c:numRef>
                <c:f>Foglio2!$R$131:$R$138</c:f>
                <c:numCache>
                  <c:formatCode>General</c:formatCode>
                  <c:ptCount val="8"/>
                  <c:pt idx="0">
                    <c:v>20.7</c:v>
                  </c:pt>
                  <c:pt idx="1">
                    <c:v>203.2</c:v>
                  </c:pt>
                  <c:pt idx="2">
                    <c:v>57.7</c:v>
                  </c:pt>
                  <c:pt idx="3">
                    <c:v>83.28</c:v>
                  </c:pt>
                  <c:pt idx="4">
                    <c:v>86.06</c:v>
                  </c:pt>
                  <c:pt idx="5">
                    <c:v>48.33</c:v>
                  </c:pt>
                  <c:pt idx="6">
                    <c:v>92.8</c:v>
                  </c:pt>
                  <c:pt idx="7">
                    <c:v>89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Foglio2!$O$131:$P$138</c:f>
              <c:multiLvlStrCache>
                <c:ptCount val="8"/>
                <c:lvl>
                  <c:pt idx="2">
                    <c:v>12.5 ug</c:v>
                  </c:pt>
                  <c:pt idx="3">
                    <c:v> 25 ug</c:v>
                  </c:pt>
                  <c:pt idx="4">
                    <c:v> 50 ug</c:v>
                  </c:pt>
                  <c:pt idx="5">
                    <c:v>12.5 ug</c:v>
                  </c:pt>
                  <c:pt idx="6">
                    <c:v> 25 ug</c:v>
                  </c:pt>
                  <c:pt idx="7">
                    <c:v> 50 ug</c:v>
                  </c:pt>
                </c:lvl>
                <c:lvl>
                  <c:pt idx="0">
                    <c:v>CO</c:v>
                  </c:pt>
                  <c:pt idx="1">
                    <c:v>T3</c:v>
                  </c:pt>
                  <c:pt idx="2">
                    <c:v>TG68</c:v>
                  </c:pt>
                  <c:pt idx="5">
                    <c:v>IS25</c:v>
                  </c:pt>
                </c:lvl>
              </c:multiLvlStrCache>
            </c:multiLvlStrRef>
          </c:cat>
          <c:val>
            <c:numRef>
              <c:f>Foglio2!$Q$131:$Q$138</c:f>
              <c:numCache>
                <c:formatCode>0.00</c:formatCode>
                <c:ptCount val="8"/>
                <c:pt idx="0">
                  <c:v>780</c:v>
                </c:pt>
                <c:pt idx="1">
                  <c:v>2542.75</c:v>
                </c:pt>
                <c:pt idx="2">
                  <c:v>1051.4000000000001</c:v>
                </c:pt>
                <c:pt idx="3">
                  <c:v>1048.25</c:v>
                </c:pt>
                <c:pt idx="4">
                  <c:v>1075.5</c:v>
                </c:pt>
                <c:pt idx="5">
                  <c:v>1034.8</c:v>
                </c:pt>
                <c:pt idx="6">
                  <c:v>990</c:v>
                </c:pt>
                <c:pt idx="7">
                  <c:v>99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75-49F5-8459-D5A0E4649F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423230096"/>
        <c:axId val="423237640"/>
      </c:barChart>
      <c:catAx>
        <c:axId val="42323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7640"/>
        <c:crosses val="autoZero"/>
        <c:auto val="1"/>
        <c:lblAlgn val="ctr"/>
        <c:lblOffset val="100"/>
        <c:noMultiLvlLbl val="0"/>
      </c:catAx>
      <c:valAx>
        <c:axId val="423237640"/>
        <c:scaling>
          <c:orientation val="minMax"/>
          <c:max val="3000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0096"/>
        <c:crosses val="autoZero"/>
        <c:crossBetween val="between"/>
        <c:majorUnit val="1000"/>
        <c:min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b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T (U/I)</a:t>
            </a:r>
          </a:p>
        </c:rich>
      </c:tx>
      <c:layout>
        <c:manualLayout>
          <c:xMode val="edge"/>
          <c:yMode val="edge"/>
          <c:x val="0.46640966754155733"/>
          <c:y val="0.12132478632478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9B4-4019-AD9B-92D09A4303A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79B4-4019-AD9B-92D09A4303A8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9B4-4019-AD9B-92D09A4303A8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79B4-4019-AD9B-92D09A4303A8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9B4-4019-AD9B-92D09A4303A8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79B4-4019-AD9B-92D09A4303A8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9B4-4019-AD9B-92D09A4303A8}"/>
              </c:ext>
            </c:extLst>
          </c:dPt>
          <c:errBars>
            <c:errBarType val="both"/>
            <c:errValType val="cust"/>
            <c:noEndCap val="0"/>
            <c:plus>
              <c:numRef>
                <c:f>Foglio2!$R$154:$R$161</c:f>
                <c:numCache>
                  <c:formatCode>General</c:formatCode>
                  <c:ptCount val="8"/>
                  <c:pt idx="0">
                    <c:v>1.69</c:v>
                  </c:pt>
                  <c:pt idx="1">
                    <c:v>1.22</c:v>
                  </c:pt>
                  <c:pt idx="2">
                    <c:v>2.06</c:v>
                  </c:pt>
                  <c:pt idx="3">
                    <c:v>1.8</c:v>
                  </c:pt>
                  <c:pt idx="4">
                    <c:v>1.41</c:v>
                  </c:pt>
                  <c:pt idx="5">
                    <c:v>2.68</c:v>
                  </c:pt>
                  <c:pt idx="6">
                    <c:v>1.33</c:v>
                  </c:pt>
                  <c:pt idx="7">
                    <c:v>1.9</c:v>
                  </c:pt>
                </c:numCache>
              </c:numRef>
            </c:plus>
            <c:minus>
              <c:numRef>
                <c:f>Foglio2!$R$154:$R$161</c:f>
                <c:numCache>
                  <c:formatCode>General</c:formatCode>
                  <c:ptCount val="8"/>
                  <c:pt idx="0">
                    <c:v>1.69</c:v>
                  </c:pt>
                  <c:pt idx="1">
                    <c:v>1.22</c:v>
                  </c:pt>
                  <c:pt idx="2">
                    <c:v>2.06</c:v>
                  </c:pt>
                  <c:pt idx="3">
                    <c:v>1.8</c:v>
                  </c:pt>
                  <c:pt idx="4">
                    <c:v>1.41</c:v>
                  </c:pt>
                  <c:pt idx="5">
                    <c:v>2.68</c:v>
                  </c:pt>
                  <c:pt idx="6">
                    <c:v>1.33</c:v>
                  </c:pt>
                  <c:pt idx="7">
                    <c:v>1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Foglio2!$O$154:$P$161</c:f>
              <c:multiLvlStrCache>
                <c:ptCount val="8"/>
                <c:lvl>
                  <c:pt idx="2">
                    <c:v>12.5 ug</c:v>
                  </c:pt>
                  <c:pt idx="3">
                    <c:v> 25 ug</c:v>
                  </c:pt>
                  <c:pt idx="4">
                    <c:v> 50 ug</c:v>
                  </c:pt>
                  <c:pt idx="5">
                    <c:v>12.5 ug</c:v>
                  </c:pt>
                  <c:pt idx="6">
                    <c:v> 25 ug</c:v>
                  </c:pt>
                  <c:pt idx="7">
                    <c:v> 50 ug</c:v>
                  </c:pt>
                </c:lvl>
                <c:lvl>
                  <c:pt idx="0">
                    <c:v>CO</c:v>
                  </c:pt>
                  <c:pt idx="1">
                    <c:v>T3</c:v>
                  </c:pt>
                  <c:pt idx="2">
                    <c:v>TG68</c:v>
                  </c:pt>
                  <c:pt idx="5">
                    <c:v>IS25</c:v>
                  </c:pt>
                </c:lvl>
              </c:multiLvlStrCache>
            </c:multiLvlStrRef>
          </c:cat>
          <c:val>
            <c:numRef>
              <c:f>Foglio2!$Q$154:$Q$161</c:f>
              <c:numCache>
                <c:formatCode>0.00</c:formatCode>
                <c:ptCount val="8"/>
                <c:pt idx="0" formatCode="General">
                  <c:v>5.5</c:v>
                </c:pt>
                <c:pt idx="1">
                  <c:v>7.8</c:v>
                </c:pt>
                <c:pt idx="2">
                  <c:v>5.34</c:v>
                </c:pt>
                <c:pt idx="3">
                  <c:v>3.63</c:v>
                </c:pt>
                <c:pt idx="4">
                  <c:v>4.45</c:v>
                </c:pt>
                <c:pt idx="5">
                  <c:v>5.5</c:v>
                </c:pt>
                <c:pt idx="6">
                  <c:v>4.1399999999999997</c:v>
                </c:pt>
                <c:pt idx="7">
                  <c:v>2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B4-4019-AD9B-92D09A4303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423230096"/>
        <c:axId val="423237640"/>
      </c:barChart>
      <c:catAx>
        <c:axId val="42323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7640"/>
        <c:crosses val="autoZero"/>
        <c:auto val="1"/>
        <c:lblAlgn val="ctr"/>
        <c:lblOffset val="100"/>
        <c:noMultiLvlLbl val="0"/>
      </c:catAx>
      <c:valAx>
        <c:axId val="423237640"/>
        <c:scaling>
          <c:orientation val="minMax"/>
          <c:max val="10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0096"/>
        <c:crosses val="autoZero"/>
        <c:crossBetween val="between"/>
        <c:majorUnit val="2"/>
        <c:min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B (mg/dl)</a:t>
            </a:r>
          </a:p>
        </c:rich>
      </c:tx>
      <c:layout>
        <c:manualLayout>
          <c:xMode val="edge"/>
          <c:yMode val="edge"/>
          <c:x val="0.45104054194363719"/>
          <c:y val="0.112863247863247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020-4F17-ACCB-A1AF3B78E5A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020-4F17-ACCB-A1AF3B78E5A3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020-4F17-ACCB-A1AF3B78E5A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3020-4F17-ACCB-A1AF3B78E5A3}"/>
              </c:ext>
            </c:extLst>
          </c:dPt>
          <c:dPt>
            <c:idx val="5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020-4F17-ACCB-A1AF3B78E5A3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3020-4F17-ACCB-A1AF3B78E5A3}"/>
              </c:ext>
            </c:extLst>
          </c:dPt>
          <c:dPt>
            <c:idx val="7"/>
            <c:invertIfNegative val="0"/>
            <c:bubble3D val="0"/>
            <c:spPr>
              <a:pattFill prst="wdUp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020-4F17-ACCB-A1AF3B78E5A3}"/>
              </c:ext>
            </c:extLst>
          </c:dPt>
          <c:errBars>
            <c:errBarType val="both"/>
            <c:errValType val="cust"/>
            <c:noEndCap val="0"/>
            <c:plus>
              <c:numRef>
                <c:f>Foglio2!$R$184:$R$191</c:f>
                <c:numCache>
                  <c:formatCode>General</c:formatCode>
                  <c:ptCount val="8"/>
                  <c:pt idx="0">
                    <c:v>0.08</c:v>
                  </c:pt>
                  <c:pt idx="1">
                    <c:v>0.27</c:v>
                  </c:pt>
                  <c:pt idx="2">
                    <c:v>0.08</c:v>
                  </c:pt>
                  <c:pt idx="3">
                    <c:v>0.34</c:v>
                  </c:pt>
                  <c:pt idx="4">
                    <c:v>0.13</c:v>
                  </c:pt>
                  <c:pt idx="5">
                    <c:v>0.17</c:v>
                  </c:pt>
                  <c:pt idx="6">
                    <c:v>0.16</c:v>
                  </c:pt>
                  <c:pt idx="7">
                    <c:v>0.14000000000000001</c:v>
                  </c:pt>
                </c:numCache>
              </c:numRef>
            </c:plus>
            <c:minus>
              <c:numRef>
                <c:f>Foglio2!$R$184:$R$191</c:f>
                <c:numCache>
                  <c:formatCode>General</c:formatCode>
                  <c:ptCount val="8"/>
                  <c:pt idx="0">
                    <c:v>0.08</c:v>
                  </c:pt>
                  <c:pt idx="1">
                    <c:v>0.27</c:v>
                  </c:pt>
                  <c:pt idx="2">
                    <c:v>0.08</c:v>
                  </c:pt>
                  <c:pt idx="3">
                    <c:v>0.34</c:v>
                  </c:pt>
                  <c:pt idx="4">
                    <c:v>0.13</c:v>
                  </c:pt>
                  <c:pt idx="5">
                    <c:v>0.17</c:v>
                  </c:pt>
                  <c:pt idx="6">
                    <c:v>0.16</c:v>
                  </c:pt>
                  <c:pt idx="7">
                    <c:v>0.140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Foglio2!$O$184:$P$191</c:f>
              <c:multiLvlStrCache>
                <c:ptCount val="8"/>
                <c:lvl>
                  <c:pt idx="2">
                    <c:v>12.5 ug</c:v>
                  </c:pt>
                  <c:pt idx="3">
                    <c:v> 25 ug</c:v>
                  </c:pt>
                  <c:pt idx="4">
                    <c:v> 50 ug</c:v>
                  </c:pt>
                  <c:pt idx="5">
                    <c:v>12.5 ug</c:v>
                  </c:pt>
                  <c:pt idx="6">
                    <c:v> 25 ug</c:v>
                  </c:pt>
                  <c:pt idx="7">
                    <c:v> 50 ug</c:v>
                  </c:pt>
                </c:lvl>
                <c:lvl>
                  <c:pt idx="0">
                    <c:v>CO</c:v>
                  </c:pt>
                  <c:pt idx="1">
                    <c:v>T3</c:v>
                  </c:pt>
                  <c:pt idx="2">
                    <c:v>TG68</c:v>
                  </c:pt>
                  <c:pt idx="5">
                    <c:v>IS25</c:v>
                  </c:pt>
                </c:lvl>
              </c:multiLvlStrCache>
            </c:multiLvlStrRef>
          </c:cat>
          <c:val>
            <c:numRef>
              <c:f>Foglio2!$Q$184:$Q$191</c:f>
              <c:numCache>
                <c:formatCode>0.00</c:formatCode>
                <c:ptCount val="8"/>
                <c:pt idx="0" formatCode="General">
                  <c:v>0.9</c:v>
                </c:pt>
                <c:pt idx="1">
                  <c:v>0.93</c:v>
                </c:pt>
                <c:pt idx="2">
                  <c:v>1</c:v>
                </c:pt>
                <c:pt idx="3">
                  <c:v>1.17</c:v>
                </c:pt>
                <c:pt idx="4">
                  <c:v>0.9</c:v>
                </c:pt>
                <c:pt idx="5">
                  <c:v>0.78</c:v>
                </c:pt>
                <c:pt idx="6">
                  <c:v>0.98</c:v>
                </c:pt>
                <c:pt idx="7">
                  <c:v>1.01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20-4F17-ACCB-A1AF3B78E5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423230096"/>
        <c:axId val="423237640"/>
      </c:barChart>
      <c:catAx>
        <c:axId val="42323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7640"/>
        <c:crosses val="autoZero"/>
        <c:auto val="1"/>
        <c:lblAlgn val="ctr"/>
        <c:lblOffset val="100"/>
        <c:noMultiLvlLbl val="0"/>
      </c:catAx>
      <c:valAx>
        <c:axId val="423237640"/>
        <c:scaling>
          <c:orientation val="minMax"/>
          <c:max val="2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30096"/>
        <c:crosses val="autoZero"/>
        <c:crossBetween val="between"/>
        <c:majorUnit val="0.5"/>
        <c:min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86E149-CE97-4B01-9A8D-5852BAFFB748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085EB1-76C4-4F1C-BFF8-9A30454F97A4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00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AEBAAC-05EE-43A1-A267-FE473DC19EB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CE6DA7-7504-4D0C-9CEA-390EA2B53BF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154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CE6DA7-7504-4D0C-9CEA-390EA2B53B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4086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CE6DA7-7504-4D0C-9CEA-390EA2B53BF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1788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9610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8534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336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7792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3179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5181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003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5010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6207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904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7764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82706-CB2A-404D-9DDF-E33A022088F2}" type="datetimeFigureOut">
              <a:rPr lang="it-IT" smtClean="0"/>
              <a:t>02/03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D47D8-3E9F-44BC-88CF-2CB248D70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0005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openxmlformats.org/officeDocument/2006/relationships/image" Target="../media/image9.jpe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51575" y="6334374"/>
            <a:ext cx="1368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. Fig. </a:t>
            </a:r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942F7D14-5CD6-4F04-96A4-0D6694106A6A}"/>
              </a:ext>
            </a:extLst>
          </p:cNvPr>
          <p:cNvSpPr txBox="1"/>
          <p:nvPr/>
        </p:nvSpPr>
        <p:spPr>
          <a:xfrm>
            <a:off x="1519726" y="135926"/>
            <a:ext cx="373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E9EA2DA-22F2-4095-A1E6-784E1B62AA8A}"/>
              </a:ext>
            </a:extLst>
          </p:cNvPr>
          <p:cNvSpPr txBox="1"/>
          <p:nvPr/>
        </p:nvSpPr>
        <p:spPr>
          <a:xfrm>
            <a:off x="1519726" y="2276872"/>
            <a:ext cx="373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8F9BCEF7-3461-4035-A5D3-8DB5E81279B6}"/>
              </a:ext>
            </a:extLst>
          </p:cNvPr>
          <p:cNvGrpSpPr/>
          <p:nvPr/>
        </p:nvGrpSpPr>
        <p:grpSpPr>
          <a:xfrm>
            <a:off x="2123728" y="0"/>
            <a:ext cx="4572000" cy="2204864"/>
            <a:chOff x="2051720" y="115982"/>
            <a:chExt cx="4572000" cy="2743200"/>
          </a:xfrm>
        </p:grpSpPr>
        <p:graphicFrame>
          <p:nvGraphicFramePr>
            <p:cNvPr id="21" name="Grafico 20">
              <a:extLst>
                <a:ext uri="{FF2B5EF4-FFF2-40B4-BE49-F238E27FC236}">
                  <a16:creationId xmlns:a16="http://schemas.microsoft.com/office/drawing/2014/main" id="{75262EAC-1A30-4090-96D7-AF315DBCC6FD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051720" y="11598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4F7C4145-41EA-4EA7-9BF3-6DAA6A0B3156}"/>
                </a:ext>
              </a:extLst>
            </p:cNvPr>
            <p:cNvSpPr txBox="1"/>
            <p:nvPr/>
          </p:nvSpPr>
          <p:spPr>
            <a:xfrm>
              <a:off x="3113672" y="459746"/>
              <a:ext cx="471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06FA3402-27D2-4F78-8972-5CAD4D93E519}"/>
                </a:ext>
              </a:extLst>
            </p:cNvPr>
            <p:cNvSpPr txBox="1"/>
            <p:nvPr/>
          </p:nvSpPr>
          <p:spPr>
            <a:xfrm>
              <a:off x="4582263" y="1285439"/>
              <a:ext cx="471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675E53E7-E1A6-4623-9A59-5D0239F21FBA}"/>
                </a:ext>
              </a:extLst>
            </p:cNvPr>
            <p:cNvSpPr txBox="1"/>
            <p:nvPr/>
          </p:nvSpPr>
          <p:spPr>
            <a:xfrm>
              <a:off x="5053317" y="1285439"/>
              <a:ext cx="471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998B2CB2-2302-4833-B529-C4FE2BC2A6CC}"/>
                </a:ext>
              </a:extLst>
            </p:cNvPr>
            <p:cNvSpPr txBox="1"/>
            <p:nvPr/>
          </p:nvSpPr>
          <p:spPr>
            <a:xfrm>
              <a:off x="4094540" y="1285439"/>
              <a:ext cx="471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DAA8257E-879F-440F-8ACC-A1594B796842}"/>
                </a:ext>
              </a:extLst>
            </p:cNvPr>
            <p:cNvSpPr txBox="1"/>
            <p:nvPr/>
          </p:nvSpPr>
          <p:spPr>
            <a:xfrm>
              <a:off x="3600224" y="1285439"/>
              <a:ext cx="471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aphicFrame>
        <p:nvGraphicFramePr>
          <p:cNvPr id="15" name="Grafico 14">
            <a:extLst>
              <a:ext uri="{FF2B5EF4-FFF2-40B4-BE49-F238E27FC236}">
                <a16:creationId xmlns:a16="http://schemas.microsoft.com/office/drawing/2014/main" id="{6D57FEDF-B55F-4C24-84B7-3F5EB482EB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77425"/>
              </p:ext>
            </p:extLst>
          </p:nvPr>
        </p:nvGraphicFramePr>
        <p:xfrm>
          <a:off x="2267744" y="2271720"/>
          <a:ext cx="4572000" cy="2123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07CB613-2F93-414D-A1C0-DDA69C827DD3}"/>
              </a:ext>
            </a:extLst>
          </p:cNvPr>
          <p:cNvSpPr txBox="1"/>
          <p:nvPr/>
        </p:nvSpPr>
        <p:spPr>
          <a:xfrm>
            <a:off x="1519726" y="4454170"/>
            <a:ext cx="373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Grafico 16">
            <a:extLst>
              <a:ext uri="{FF2B5EF4-FFF2-40B4-BE49-F238E27FC236}">
                <a16:creationId xmlns:a16="http://schemas.microsoft.com/office/drawing/2014/main" id="{DC2B9D1C-E6A9-4C13-A146-FF892215FA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0420977"/>
              </p:ext>
            </p:extLst>
          </p:nvPr>
        </p:nvGraphicFramePr>
        <p:xfrm>
          <a:off x="2351602" y="4394321"/>
          <a:ext cx="4488142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3137892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o 8"/>
          <p:cNvGrpSpPr/>
          <p:nvPr/>
        </p:nvGrpSpPr>
        <p:grpSpPr>
          <a:xfrm>
            <a:off x="1707231" y="3524639"/>
            <a:ext cx="2755052" cy="1634882"/>
            <a:chOff x="1561078" y="245766"/>
            <a:chExt cx="2932333" cy="1634882"/>
          </a:xfrm>
        </p:grpSpPr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D520D0C5-BF33-4BFC-B763-365197A131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9672" y="260648"/>
              <a:ext cx="2873739" cy="1620000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6E5D88F7-22DC-4CBE-B0FA-FE8667383B96}"/>
                </a:ext>
              </a:extLst>
            </p:cNvPr>
            <p:cNvSpPr txBox="1"/>
            <p:nvPr/>
          </p:nvSpPr>
          <p:spPr>
            <a:xfrm>
              <a:off x="1561078" y="245766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</a:p>
          </p:txBody>
        </p:sp>
      </p:grpSp>
      <p:grpSp>
        <p:nvGrpSpPr>
          <p:cNvPr id="11" name="Gruppo 10"/>
          <p:cNvGrpSpPr/>
          <p:nvPr/>
        </p:nvGrpSpPr>
        <p:grpSpPr>
          <a:xfrm>
            <a:off x="4312787" y="3506656"/>
            <a:ext cx="2887339" cy="1652866"/>
            <a:chOff x="4386374" y="275642"/>
            <a:chExt cx="2989143" cy="1607603"/>
          </a:xfrm>
        </p:grpSpPr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EBC24134-B221-4DDF-A39F-B4405734B05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9412" y="307008"/>
              <a:ext cx="2796105" cy="1576237"/>
            </a:xfrm>
            <a:prstGeom prst="rect">
              <a:avLst/>
            </a:prstGeom>
          </p:spPr>
        </p:pic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22B97D07-DC53-4B96-887A-23D91A735E04}"/>
                </a:ext>
              </a:extLst>
            </p:cNvPr>
            <p:cNvSpPr txBox="1"/>
            <p:nvPr/>
          </p:nvSpPr>
          <p:spPr>
            <a:xfrm>
              <a:off x="4386374" y="275642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</p:grpSp>
      <p:grpSp>
        <p:nvGrpSpPr>
          <p:cNvPr id="2" name="Gruppo 1"/>
          <p:cNvGrpSpPr/>
          <p:nvPr/>
        </p:nvGrpSpPr>
        <p:grpSpPr>
          <a:xfrm>
            <a:off x="1700737" y="5220444"/>
            <a:ext cx="2744487" cy="1607901"/>
            <a:chOff x="1347202" y="2420954"/>
            <a:chExt cx="2929587" cy="1620000"/>
          </a:xfrm>
        </p:grpSpPr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266C7C7A-910F-4014-B6F3-0312880F4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03049" y="2420954"/>
              <a:ext cx="2873740" cy="1620000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5035F3C1-FB22-4CAF-B4D5-B225C2E9D9CC}"/>
                </a:ext>
              </a:extLst>
            </p:cNvPr>
            <p:cNvSpPr txBox="1"/>
            <p:nvPr/>
          </p:nvSpPr>
          <p:spPr>
            <a:xfrm>
              <a:off x="1347202" y="2422905"/>
              <a:ext cx="912707" cy="651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68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50 </a:t>
              </a:r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)</a:t>
              </a:r>
            </a:p>
            <a:p>
              <a:endParaRPr 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4453044" y="5191771"/>
            <a:ext cx="2725094" cy="1636574"/>
            <a:chOff x="1354811" y="6865461"/>
            <a:chExt cx="2928226" cy="1713895"/>
          </a:xfrm>
        </p:grpSpPr>
        <p:pic>
          <p:nvPicPr>
            <p:cNvPr id="22" name="Immagine 21">
              <a:extLst>
                <a:ext uri="{FF2B5EF4-FFF2-40B4-BE49-F238E27FC236}">
                  <a16:creationId xmlns:a16="http://schemas.microsoft.com/office/drawing/2014/main" id="{31B8B596-0111-4F5F-8D4C-07261B26E75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09297" y="6883616"/>
              <a:ext cx="2873740" cy="1695740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E63CC97C-2C5B-4772-9960-BF6AD85F136E}"/>
                </a:ext>
              </a:extLst>
            </p:cNvPr>
            <p:cNvSpPr txBox="1"/>
            <p:nvPr/>
          </p:nvSpPr>
          <p:spPr>
            <a:xfrm>
              <a:off x="1354811" y="6865461"/>
              <a:ext cx="866809" cy="4834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25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</p:grpSp>
      <p:grpSp>
        <p:nvGrpSpPr>
          <p:cNvPr id="17" name="Gruppo 16"/>
          <p:cNvGrpSpPr/>
          <p:nvPr/>
        </p:nvGrpSpPr>
        <p:grpSpPr>
          <a:xfrm>
            <a:off x="1718490" y="68060"/>
            <a:ext cx="2737994" cy="1639672"/>
            <a:chOff x="1488697" y="94276"/>
            <a:chExt cx="2932707" cy="1626086"/>
          </a:xfrm>
        </p:grpSpPr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B4B54B60-5569-46F0-AEA1-CE1B9005B4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7665" y="100362"/>
              <a:ext cx="2873739" cy="1620000"/>
            </a:xfrm>
            <a:prstGeom prst="rect">
              <a:avLst/>
            </a:prstGeom>
          </p:spPr>
        </p:pic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642AE275-917F-4E0C-9DD8-E45D1EBBEAAE}"/>
                </a:ext>
              </a:extLst>
            </p:cNvPr>
            <p:cNvSpPr txBox="1"/>
            <p:nvPr/>
          </p:nvSpPr>
          <p:spPr>
            <a:xfrm>
              <a:off x="1488697" y="94276"/>
              <a:ext cx="6483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</a:p>
          </p:txBody>
        </p:sp>
      </p:grpSp>
      <p:grpSp>
        <p:nvGrpSpPr>
          <p:cNvPr id="23" name="Gruppo 22"/>
          <p:cNvGrpSpPr/>
          <p:nvPr/>
        </p:nvGrpSpPr>
        <p:grpSpPr>
          <a:xfrm>
            <a:off x="4455656" y="70810"/>
            <a:ext cx="2744470" cy="1628330"/>
            <a:chOff x="1488101" y="1759057"/>
            <a:chExt cx="2933303" cy="1626128"/>
          </a:xfrm>
        </p:grpSpPr>
        <p:pic>
          <p:nvPicPr>
            <p:cNvPr id="24" name="Immagine 23">
              <a:extLst>
                <a:ext uri="{FF2B5EF4-FFF2-40B4-BE49-F238E27FC236}">
                  <a16:creationId xmlns:a16="http://schemas.microsoft.com/office/drawing/2014/main" id="{F348DF5D-AF57-4ED0-9713-547707A290B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7666" y="1765185"/>
              <a:ext cx="2873738" cy="1620000"/>
            </a:xfrm>
            <a:prstGeom prst="rect">
              <a:avLst/>
            </a:prstGeom>
          </p:spPr>
        </p:pic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AA572FAC-C753-4C3B-BBCD-717E5FF496DD}"/>
                </a:ext>
              </a:extLst>
            </p:cNvPr>
            <p:cNvSpPr txBox="1"/>
            <p:nvPr/>
          </p:nvSpPr>
          <p:spPr>
            <a:xfrm>
              <a:off x="1488101" y="1759057"/>
              <a:ext cx="6483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</p:grpSp>
      <p:grpSp>
        <p:nvGrpSpPr>
          <p:cNvPr id="26" name="Gruppo 25"/>
          <p:cNvGrpSpPr/>
          <p:nvPr/>
        </p:nvGrpSpPr>
        <p:grpSpPr>
          <a:xfrm>
            <a:off x="1718490" y="1717811"/>
            <a:ext cx="2743793" cy="1613303"/>
            <a:chOff x="1488824" y="3413137"/>
            <a:chExt cx="2932580" cy="1639691"/>
          </a:xfrm>
        </p:grpSpPr>
        <p:pic>
          <p:nvPicPr>
            <p:cNvPr id="27" name="Immagine 26">
              <a:extLst>
                <a:ext uri="{FF2B5EF4-FFF2-40B4-BE49-F238E27FC236}">
                  <a16:creationId xmlns:a16="http://schemas.microsoft.com/office/drawing/2014/main" id="{EBA55920-57B2-49B7-83C2-EA6848897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7665" y="3432828"/>
              <a:ext cx="2873739" cy="1620000"/>
            </a:xfrm>
            <a:prstGeom prst="rect">
              <a:avLst/>
            </a:prstGeom>
          </p:spPr>
        </p:pic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3C85E4F0-C53E-4A1B-983E-E30814BCC0C7}"/>
                </a:ext>
              </a:extLst>
            </p:cNvPr>
            <p:cNvSpPr txBox="1"/>
            <p:nvPr/>
          </p:nvSpPr>
          <p:spPr>
            <a:xfrm>
              <a:off x="1488824" y="3413137"/>
              <a:ext cx="848090" cy="469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68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50 </a:t>
              </a:r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)</a:t>
              </a:r>
            </a:p>
          </p:txBody>
        </p:sp>
      </p:grpSp>
      <p:grpSp>
        <p:nvGrpSpPr>
          <p:cNvPr id="29" name="Gruppo 28"/>
          <p:cNvGrpSpPr/>
          <p:nvPr/>
        </p:nvGrpSpPr>
        <p:grpSpPr>
          <a:xfrm>
            <a:off x="4453044" y="1715173"/>
            <a:ext cx="2747910" cy="1603297"/>
            <a:chOff x="1177095" y="5079809"/>
            <a:chExt cx="2936979" cy="1627911"/>
          </a:xfrm>
        </p:grpSpPr>
        <p:pic>
          <p:nvPicPr>
            <p:cNvPr id="30" name="Immagine 29">
              <a:extLst>
                <a:ext uri="{FF2B5EF4-FFF2-40B4-BE49-F238E27FC236}">
                  <a16:creationId xmlns:a16="http://schemas.microsoft.com/office/drawing/2014/main" id="{A8CB3CB3-F300-41DC-BC8F-7912CB256D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0335" y="5087720"/>
              <a:ext cx="2873739" cy="1620000"/>
            </a:xfrm>
            <a:prstGeom prst="rect">
              <a:avLst/>
            </a:prstGeom>
          </p:spPr>
        </p:pic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8224902A-7B88-4626-B37E-3AF3BC3B48E2}"/>
                </a:ext>
              </a:extLst>
            </p:cNvPr>
            <p:cNvSpPr txBox="1"/>
            <p:nvPr/>
          </p:nvSpPr>
          <p:spPr>
            <a:xfrm>
              <a:off x="1177095" y="5079809"/>
              <a:ext cx="834718" cy="468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25</a:t>
              </a:r>
            </a:p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it-IT" sz="1200" b="1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</p:grpSp>
      <p:sp>
        <p:nvSpPr>
          <p:cNvPr id="32" name="CasellaDiTesto 31"/>
          <p:cNvSpPr txBox="1"/>
          <p:nvPr/>
        </p:nvSpPr>
        <p:spPr>
          <a:xfrm>
            <a:off x="77070" y="6381328"/>
            <a:ext cx="1247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. Fig. 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051544" y="34180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051544" y="4527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01A0326B-735F-ED4F-B492-2C2CC3286B57}"/>
              </a:ext>
            </a:extLst>
          </p:cNvPr>
          <p:cNvSpPr/>
          <p:nvPr/>
        </p:nvSpPr>
        <p:spPr>
          <a:xfrm>
            <a:off x="1700737" y="29655"/>
            <a:ext cx="5607567" cy="3349309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Rettangolo 32">
            <a:extLst>
              <a:ext uri="{FF2B5EF4-FFF2-40B4-BE49-F238E27FC236}">
                <a16:creationId xmlns:a16="http://schemas.microsoft.com/office/drawing/2014/main" id="{6B674C86-3674-EC48-B7C1-6CE263B3D5F5}"/>
              </a:ext>
            </a:extLst>
          </p:cNvPr>
          <p:cNvSpPr/>
          <p:nvPr/>
        </p:nvSpPr>
        <p:spPr>
          <a:xfrm>
            <a:off x="1700737" y="3465414"/>
            <a:ext cx="5607567" cy="3378964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6224A1B-9824-8248-8F78-574086D27129}"/>
              </a:ext>
            </a:extLst>
          </p:cNvPr>
          <p:cNvSpPr txBox="1"/>
          <p:nvPr/>
        </p:nvSpPr>
        <p:spPr>
          <a:xfrm>
            <a:off x="7410036" y="1535104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20X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C75EC4C3-9FAA-B045-BEDC-94FE84B99865}"/>
              </a:ext>
            </a:extLst>
          </p:cNvPr>
          <p:cNvSpPr txBox="1"/>
          <p:nvPr/>
        </p:nvSpPr>
        <p:spPr>
          <a:xfrm>
            <a:off x="7380634" y="5040905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40X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58445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8063A4C4-025C-4638-91FB-01DD49B1F77E}"/>
              </a:ext>
            </a:extLst>
          </p:cNvPr>
          <p:cNvSpPr txBox="1"/>
          <p:nvPr/>
        </p:nvSpPr>
        <p:spPr>
          <a:xfrm>
            <a:off x="687763" y="125781"/>
            <a:ext cx="961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02E52C9C-6BEC-40CA-A501-727DC1878682}"/>
              </a:ext>
            </a:extLst>
          </p:cNvPr>
          <p:cNvSpPr txBox="1"/>
          <p:nvPr/>
        </p:nvSpPr>
        <p:spPr>
          <a:xfrm>
            <a:off x="664419" y="350738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6A2118FF-7B1B-433B-8719-A3A115351B13}"/>
              </a:ext>
            </a:extLst>
          </p:cNvPr>
          <p:cNvSpPr txBox="1"/>
          <p:nvPr/>
        </p:nvSpPr>
        <p:spPr>
          <a:xfrm>
            <a:off x="5485888" y="-11998"/>
            <a:ext cx="1045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07CB749-48D8-4A0C-BDC3-F75F4E662116}"/>
              </a:ext>
            </a:extLst>
          </p:cNvPr>
          <p:cNvSpPr txBox="1"/>
          <p:nvPr/>
        </p:nvSpPr>
        <p:spPr>
          <a:xfrm>
            <a:off x="7240476" y="1697106"/>
            <a:ext cx="1045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20X H&amp;E </a:t>
            </a:r>
          </a:p>
        </p:txBody>
      </p:sp>
      <p:pic>
        <p:nvPicPr>
          <p:cNvPr id="10" name="Immagine 9">
            <a:extLst>
              <a:ext uri="{FF2B5EF4-FFF2-40B4-BE49-F238E27FC236}">
                <a16:creationId xmlns:a16="http://schemas.microsoft.com/office/drawing/2014/main" id="{60BC293A-ED11-4023-A98C-1058BA1C110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3625" y="3605144"/>
            <a:ext cx="2761625" cy="1556798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AB13277F-5D83-4C35-A87B-7284C196D78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352" y="5179382"/>
            <a:ext cx="2761625" cy="1556798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0BE44224-96B2-4CAE-86EC-98817983196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6062" y="5192635"/>
            <a:ext cx="2761625" cy="1556798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E3B74FE5-A252-4C3B-A6A4-D01F3C33011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352" y="3605144"/>
            <a:ext cx="2761624" cy="1556798"/>
          </a:xfrm>
          <a:prstGeom prst="rect">
            <a:avLst/>
          </a:prstGeom>
        </p:spPr>
      </p:pic>
      <p:pic>
        <p:nvPicPr>
          <p:cNvPr id="2" name="Immagine 1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2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28657" y="251280"/>
            <a:ext cx="5569936" cy="3164855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-19926" y="6391797"/>
            <a:ext cx="12474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. Fig. 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ttangolo 12">
            <a:extLst>
              <a:ext uri="{FF2B5EF4-FFF2-40B4-BE49-F238E27FC236}">
                <a16:creationId xmlns:a16="http://schemas.microsoft.com/office/drawing/2014/main" id="{16B33269-D7B5-0842-AF15-10DD31EE66B0}"/>
              </a:ext>
            </a:extLst>
          </p:cNvPr>
          <p:cNvSpPr/>
          <p:nvPr/>
        </p:nvSpPr>
        <p:spPr>
          <a:xfrm>
            <a:off x="1547665" y="226481"/>
            <a:ext cx="5688632" cy="3241283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AB6D8470-8FCF-4647-BB8F-5AD68998A94B}"/>
              </a:ext>
            </a:extLst>
          </p:cNvPr>
          <p:cNvSpPr/>
          <p:nvPr/>
        </p:nvSpPr>
        <p:spPr>
          <a:xfrm>
            <a:off x="1544267" y="3526524"/>
            <a:ext cx="5688632" cy="3241283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1A42DCDA-025E-3B42-9C8C-8A4D551175F9}"/>
              </a:ext>
            </a:extLst>
          </p:cNvPr>
          <p:cNvSpPr txBox="1"/>
          <p:nvPr/>
        </p:nvSpPr>
        <p:spPr>
          <a:xfrm>
            <a:off x="1551974" y="36132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O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F9609CC2-1AC3-0345-851D-02856EEA8835}"/>
              </a:ext>
            </a:extLst>
          </p:cNvPr>
          <p:cNvSpPr txBox="1"/>
          <p:nvPr/>
        </p:nvSpPr>
        <p:spPr>
          <a:xfrm>
            <a:off x="4420538" y="3613219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T3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EBAEA15-9D17-B441-937E-D18F167ACAAF}"/>
              </a:ext>
            </a:extLst>
          </p:cNvPr>
          <p:cNvSpPr txBox="1"/>
          <p:nvPr/>
        </p:nvSpPr>
        <p:spPr>
          <a:xfrm>
            <a:off x="1555489" y="523488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TG68 50 </a:t>
            </a:r>
            <a:r>
              <a:rPr lang="it-IT" sz="1000" b="1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AD31020-95DC-2349-9737-3CE4FEA71CE6}"/>
              </a:ext>
            </a:extLst>
          </p:cNvPr>
          <p:cNvSpPr txBox="1"/>
          <p:nvPr/>
        </p:nvSpPr>
        <p:spPr>
          <a:xfrm>
            <a:off x="4406062" y="522070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IS25 50 </a:t>
            </a:r>
            <a:r>
              <a:rPr lang="it-IT" sz="1000" b="1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8A269667-6511-4E42-BC27-4E5A4B0D33E6}"/>
              </a:ext>
            </a:extLst>
          </p:cNvPr>
          <p:cNvSpPr txBox="1"/>
          <p:nvPr/>
        </p:nvSpPr>
        <p:spPr>
          <a:xfrm>
            <a:off x="7375105" y="5008665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40X H&amp;E</a:t>
            </a:r>
          </a:p>
        </p:txBody>
      </p:sp>
    </p:spTree>
    <p:extLst>
      <p:ext uri="{BB962C8B-B14F-4D97-AF65-F5344CB8AC3E}">
        <p14:creationId xmlns:p14="http://schemas.microsoft.com/office/powerpoint/2010/main" val="10222011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8</TotalTime>
  <Words>78</Words>
  <Application>Microsoft Office PowerPoint</Application>
  <PresentationFormat>Presentazione su schermo (4:3)</PresentationFormat>
  <Paragraphs>41</Paragraphs>
  <Slides>3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vinia</dc:creator>
  <cp:lastModifiedBy>Utente Windows</cp:lastModifiedBy>
  <cp:revision>159</cp:revision>
  <cp:lastPrinted>2019-12-05T14:00:01Z</cp:lastPrinted>
  <dcterms:created xsi:type="dcterms:W3CDTF">2019-07-18T12:03:36Z</dcterms:created>
  <dcterms:modified xsi:type="dcterms:W3CDTF">2020-03-02T13:12:09Z</dcterms:modified>
</cp:coreProperties>
</file>